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8" d="100"/>
          <a:sy n="88" d="100"/>
        </p:scale>
        <p:origin x="-128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855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714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302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88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881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702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456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744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1140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926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0077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64730-04DE-BD47-8415-625DE5E98EE8}" type="datetimeFigureOut">
              <a:rPr lang="en-US" smtClean="0"/>
              <a:t>10/2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113F2-6571-2943-A2EF-DE2280C0C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290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b="9597"/>
          <a:stretch/>
        </p:blipFill>
        <p:spPr>
          <a:xfrm>
            <a:off x="4435417" y="1504928"/>
            <a:ext cx="2586990" cy="149441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b="9634"/>
          <a:stretch/>
        </p:blipFill>
        <p:spPr>
          <a:xfrm>
            <a:off x="1958286" y="1490601"/>
            <a:ext cx="2452504" cy="1508740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0" y="25622"/>
            <a:ext cx="14023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Additional file 2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5554" y="3423622"/>
            <a:ext cx="1746093" cy="172527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16200000">
            <a:off x="4664667" y="3716025"/>
            <a:ext cx="7806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Mouse A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4664667" y="4603186"/>
            <a:ext cx="7806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Mouse B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463706" y="29550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346840" y="3093796"/>
            <a:ext cx="20006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smtClean="0">
                <a:latin typeface="Arial" charset="0"/>
                <a:ea typeface="Arial" charset="0"/>
                <a:cs typeface="Arial" charset="0"/>
              </a:rPr>
              <a:t>µM R848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977995" y="29550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1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480009" y="29550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3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947032" y="295501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728912" y="29550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1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138871" y="29550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3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501565" y="295501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778575" y="2949362"/>
            <a:ext cx="542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TX-100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325900" y="29550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>
            <a:off x="5369444" y="3158189"/>
            <a:ext cx="1432203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5333496" y="3137604"/>
            <a:ext cx="14313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µM R848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267545" y="3315900"/>
            <a:ext cx="652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untreated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068341" y="3315900"/>
            <a:ext cx="7624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smtClean="0">
                <a:latin typeface="Arial" charset="0"/>
                <a:ea typeface="Arial" charset="0"/>
                <a:cs typeface="Arial" charset="0"/>
              </a:rPr>
              <a:t>10µM R848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192"/>
          <a:stretch/>
        </p:blipFill>
        <p:spPr>
          <a:xfrm>
            <a:off x="2188480" y="3395607"/>
            <a:ext cx="2633908" cy="1709448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2434719" y="3315900"/>
            <a:ext cx="652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 charset="0"/>
                <a:ea typeface="Arial" charset="0"/>
                <a:cs typeface="Arial" charset="0"/>
              </a:rPr>
              <a:t>untreated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235515" y="3315900"/>
            <a:ext cx="7624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smtClean="0">
                <a:latin typeface="Arial" charset="0"/>
                <a:ea typeface="Arial" charset="0"/>
                <a:cs typeface="Arial" charset="0"/>
              </a:rPr>
              <a:t>10µM R848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014820" y="3315900"/>
            <a:ext cx="8621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smtClean="0">
                <a:latin typeface="Arial" charset="0"/>
                <a:ea typeface="Arial" charset="0"/>
                <a:cs typeface="Arial" charset="0"/>
              </a:rPr>
              <a:t>100U/mL IFN⍺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1813040" y="3712333"/>
            <a:ext cx="7806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Donor 1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1813040" y="4599494"/>
            <a:ext cx="7806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Donor 2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89366" y="5076162"/>
            <a:ext cx="4510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smtClean="0">
                <a:latin typeface="Arial"/>
                <a:cs typeface="Arial"/>
              </a:rPr>
              <a:t>FSC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2105218" y="4644897"/>
            <a:ext cx="0" cy="461033"/>
          </a:xfrm>
          <a:prstGeom prst="straightConnector1">
            <a:avLst/>
          </a:prstGeom>
          <a:ln w="635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V="1">
            <a:off x="2105218" y="5105055"/>
            <a:ext cx="460159" cy="874"/>
          </a:xfrm>
          <a:prstGeom prst="straightConnector1">
            <a:avLst/>
          </a:prstGeom>
          <a:ln w="635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6200000">
            <a:off x="1698559" y="4785724"/>
            <a:ext cx="639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smtClean="0">
                <a:latin typeface="Arial"/>
                <a:cs typeface="Arial"/>
              </a:rPr>
              <a:t>PacBlue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872414" y="144153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362724" y="1443179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872414" y="329614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839203" y="329779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D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919998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Macintosh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nning hofmann</dc:creator>
  <cp:lastModifiedBy>henning hofmann</cp:lastModifiedBy>
  <cp:revision>1</cp:revision>
  <dcterms:created xsi:type="dcterms:W3CDTF">2016-10-21T10:19:16Z</dcterms:created>
  <dcterms:modified xsi:type="dcterms:W3CDTF">2016-10-21T10:19:28Z</dcterms:modified>
</cp:coreProperties>
</file>